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36576000" cy="36576000"/>
  <p:notesSz cx="6858000" cy="9144000"/>
  <p:defaultTextStyle>
    <a:defPPr>
      <a:defRPr lang="en-US"/>
    </a:defPPr>
    <a:lvl1pPr marL="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75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509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263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017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3771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526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28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03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9999"/>
    <a:srgbClr val="FFCCCC"/>
    <a:srgbClr val="FFFF99"/>
    <a:srgbClr val="FFFFCC"/>
    <a:srgbClr val="FFFFFF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9" autoAdjust="0"/>
    <p:restoredTop sz="96198" autoAdjust="0"/>
  </p:normalViewPr>
  <p:slideViewPr>
    <p:cSldViewPr>
      <p:cViewPr>
        <p:scale>
          <a:sx n="20" d="100"/>
          <a:sy n="20" d="100"/>
        </p:scale>
        <p:origin x="-2946" y="-582"/>
      </p:cViewPr>
      <p:guideLst>
        <p:guide orient="horz" pos="11520"/>
        <p:guide pos="115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11F006-DB27-4641-BAE2-FEAA289E6C5B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3EC4BE-BA03-41A4-9878-8EFEEB5B9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213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37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754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3131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7509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1886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263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64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501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11362280"/>
            <a:ext cx="31089600" cy="78401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400" y="20726400"/>
            <a:ext cx="25603200" cy="9347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486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150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143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228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1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517600" y="1464744"/>
            <a:ext cx="8229600" cy="312081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28800" y="1464744"/>
            <a:ext cx="24079200" cy="312081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098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1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9252" y="23503480"/>
            <a:ext cx="31089600" cy="7264400"/>
          </a:xfrm>
        </p:spPr>
        <p:txBody>
          <a:bodyPr anchor="t"/>
          <a:lstStyle>
            <a:lvl1pPr algn="l">
              <a:defRPr sz="16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9252" y="15502472"/>
            <a:ext cx="31089600" cy="8001000"/>
          </a:xfrm>
        </p:spPr>
        <p:txBody>
          <a:bodyPr anchor="b"/>
          <a:lstStyle>
            <a:lvl1pPr marL="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1pPr>
            <a:lvl2pPr marL="1828754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657509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3pPr>
            <a:lvl4pPr marL="5486263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4pPr>
            <a:lvl5pPr marL="7315017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5pPr>
            <a:lvl6pPr marL="9143771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711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28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92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358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187272"/>
            <a:ext cx="16160752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8800" y="11599336"/>
            <a:ext cx="16160752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80115" y="8187272"/>
            <a:ext cx="16167100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80115" y="11599336"/>
            <a:ext cx="16167100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04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924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934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10" y="1456264"/>
            <a:ext cx="12033252" cy="6197600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300200" y="1456282"/>
            <a:ext cx="20447000" cy="31216604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28810" y="7653882"/>
            <a:ext cx="12033252" cy="25019004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410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69152" y="25603203"/>
            <a:ext cx="21945600" cy="3022604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169152" y="3268136"/>
            <a:ext cx="21945600" cy="21945600"/>
          </a:xfrm>
        </p:spPr>
        <p:txBody>
          <a:bodyPr/>
          <a:lstStyle>
            <a:lvl1pPr marL="0" indent="0">
              <a:buNone/>
              <a:defRPr sz="12800"/>
            </a:lvl1pPr>
            <a:lvl2pPr marL="1828754" indent="0">
              <a:buNone/>
              <a:defRPr sz="11200"/>
            </a:lvl2pPr>
            <a:lvl3pPr marL="3657509" indent="0">
              <a:buNone/>
              <a:defRPr sz="9600"/>
            </a:lvl3pPr>
            <a:lvl4pPr marL="5486263" indent="0">
              <a:buNone/>
              <a:defRPr sz="8000"/>
            </a:lvl4pPr>
            <a:lvl5pPr marL="7315017" indent="0">
              <a:buNone/>
              <a:defRPr sz="8000"/>
            </a:lvl5pPr>
            <a:lvl6pPr marL="9143771" indent="0">
              <a:buNone/>
              <a:defRPr sz="8000"/>
            </a:lvl6pPr>
            <a:lvl7pPr marL="10972526" indent="0">
              <a:buNone/>
              <a:defRPr sz="8000"/>
            </a:lvl7pPr>
            <a:lvl8pPr marL="12801280" indent="0">
              <a:buNone/>
              <a:defRPr sz="8000"/>
            </a:lvl8pPr>
            <a:lvl9pPr marL="14630034" indent="0">
              <a:buNone/>
              <a:defRPr sz="8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69152" y="28625804"/>
            <a:ext cx="21945600" cy="4292600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028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28800" y="1464736"/>
            <a:ext cx="32918400" cy="6096000"/>
          </a:xfrm>
          <a:prstGeom prst="rect">
            <a:avLst/>
          </a:prstGeom>
        </p:spPr>
        <p:txBody>
          <a:bodyPr vert="horz" lIns="365751" tIns="182875" rIns="365751" bIns="18287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534412"/>
            <a:ext cx="32918400" cy="24138472"/>
          </a:xfrm>
          <a:prstGeom prst="rect">
            <a:avLst/>
          </a:prstGeom>
        </p:spPr>
        <p:txBody>
          <a:bodyPr vert="horz" lIns="365751" tIns="182875" rIns="365751" bIns="18287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28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496800" y="33900548"/>
            <a:ext cx="11582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212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723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509" rtl="0" eaLnBrk="1" latinLnBrk="0" hangingPunct="1"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566" indent="-1371566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1pPr>
      <a:lvl2pPr marL="2971726" indent="-1142971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11200" kern="1200">
          <a:solidFill>
            <a:schemeClr val="tx1"/>
          </a:solidFill>
          <a:latin typeface="+mn-lt"/>
          <a:ea typeface="+mn-ea"/>
          <a:cs typeface="+mn-cs"/>
        </a:defRPr>
      </a:lvl2pPr>
      <a:lvl3pPr marL="4571886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640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80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394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»"/>
        <a:defRPr sz="80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149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6903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5657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411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75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509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263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017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3771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526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28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03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33400" y="879998"/>
            <a:ext cx="19547064" cy="1477317"/>
          </a:xfrm>
          <a:prstGeom prst="rect">
            <a:avLst/>
          </a:prstGeom>
          <a:noFill/>
        </p:spPr>
        <p:txBody>
          <a:bodyPr wrap="none" lIns="365751" tIns="182875" rIns="365751" bIns="182875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ype and location of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NVs.</a:t>
            </a: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1" y="27813000"/>
            <a:ext cx="12342920" cy="3276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4557129"/>
              </p:ext>
            </p:extLst>
          </p:nvPr>
        </p:nvGraphicFramePr>
        <p:xfrm>
          <a:off x="990601" y="4114800"/>
          <a:ext cx="34366199" cy="23330166"/>
        </p:xfrm>
        <a:graphic>
          <a:graphicData uri="http://schemas.openxmlformats.org/drawingml/2006/table">
            <a:tbl>
              <a:tblPr/>
              <a:tblGrid>
                <a:gridCol w="3396498"/>
                <a:gridCol w="1987510"/>
                <a:gridCol w="1791557"/>
                <a:gridCol w="1791557"/>
                <a:gridCol w="7810076"/>
                <a:gridCol w="2426070"/>
                <a:gridCol w="7315530"/>
                <a:gridCol w="2276773"/>
                <a:gridCol w="3779071"/>
                <a:gridCol w="1791557"/>
              </a:tblGrid>
              <a:tr h="15668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se 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thogenic/likely pathogenic </a:t>
                      </a:r>
                      <a:r>
                        <a:rPr lang="en-US" sz="36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  <a:endParaRPr lang="en-US" sz="36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tein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tein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AF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90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le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N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atu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N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sition 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mai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sition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mai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%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Lys132Ar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Pro151Ala; c.993+1G&gt;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pli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?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Pro152Le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Pro153Argfs*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8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Arg158His; p.Cys275Ty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His179Ar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+dimerization+zinc binding sit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Pro190Le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His193As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Glu198*, p.Gln165delinsProProPr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3/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Tyr205S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1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p.Tyr220Cys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10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p.Tyr220Cys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10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Tyr220S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Tyr234Cy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p.Tyr234Asn, c.376-2A&gt;G;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pli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/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Tyr327Serfs*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Cys238S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+zinc binding sit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Gly245S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Arg248Gl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10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Arg248Trp; p.Lys132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8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Arg249Trp; p.Arg282Trp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Gly262Va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V272M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Arg273His, p.Arg248Gln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/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Cys275Tyr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Arg280Gl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binding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9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.Leu308Profs*3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uncation of tetramerization domai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478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6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.376-1G&gt;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pli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85179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16</TotalTime>
  <Words>309</Words>
  <Application>Microsoft Office PowerPoint</Application>
  <PresentationFormat>Custom</PresentationFormat>
  <Paragraphs>30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a Baughn</dc:creator>
  <cp:lastModifiedBy>Baughn, Linda B., Ph.D.</cp:lastModifiedBy>
  <cp:revision>312</cp:revision>
  <dcterms:created xsi:type="dcterms:W3CDTF">2019-10-01T15:18:01Z</dcterms:created>
  <dcterms:modified xsi:type="dcterms:W3CDTF">2020-12-30T22:40:33Z</dcterms:modified>
</cp:coreProperties>
</file>